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44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3078" y="90"/>
      </p:cViewPr>
      <p:guideLst>
        <p:guide orient="horz" pos="386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398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396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491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44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64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8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366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076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266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384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22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62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-26872"/>
            <a:ext cx="1667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Supplementary Figure </a:t>
            </a:r>
            <a:r>
              <a:rPr lang="en-US" sz="1200" dirty="0"/>
              <a:t>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35D5F2E-C0C9-4818-B165-A411B942CE67}"/>
              </a:ext>
            </a:extLst>
          </p:cNvPr>
          <p:cNvSpPr txBox="1"/>
          <p:nvPr/>
        </p:nvSpPr>
        <p:spPr>
          <a:xfrm>
            <a:off x="64077" y="11082629"/>
            <a:ext cx="646979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upplementary Figure 2: Treatment Related Adverse Events. Forest plot to illustrate the grade ≥3 TRAEs in the immunotherapy group compared with the comparator arm.. TRAEs: Treatment Related Adverse Events; CI: confidence interval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AB861EF-778A-4BAD-9ACB-0B568D719C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0528"/>
            <a:ext cx="6858000" cy="20850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9767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37BF873F645541AF4C0F4CF0373DF1" ma:contentTypeVersion="13" ma:contentTypeDescription="Create a new document." ma:contentTypeScope="" ma:versionID="14b5e9965609b646219bed04319feb7d">
  <xsd:schema xmlns:xsd="http://www.w3.org/2001/XMLSchema" xmlns:xs="http://www.w3.org/2001/XMLSchema" xmlns:p="http://schemas.microsoft.com/office/2006/metadata/properties" xmlns:ns3="9875dd82-a7ab-4cd3-bf7a-6baf4630d5c9" xmlns:ns4="d9837f2c-0831-4a23-8e3d-338c8fb70940" targetNamespace="http://schemas.microsoft.com/office/2006/metadata/properties" ma:root="true" ma:fieldsID="49e1f38b9eb5de44d261c8e4900ec816" ns3:_="" ns4:_="">
    <xsd:import namespace="9875dd82-a7ab-4cd3-bf7a-6baf4630d5c9"/>
    <xsd:import namespace="d9837f2c-0831-4a23-8e3d-338c8fb70940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875dd82-a7ab-4cd3-bf7a-6baf4630d5c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37f2c-0831-4a23-8e3d-338c8fb7094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4C193D5-AFA1-4CE6-93FD-505008AB8007}">
  <ds:schemaRefs>
    <ds:schemaRef ds:uri="http://purl.org/dc/elements/1.1/"/>
    <ds:schemaRef ds:uri="http://purl.org/dc/dcmitype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9875dd82-a7ab-4cd3-bf7a-6baf4630d5c9"/>
    <ds:schemaRef ds:uri="http://schemas.openxmlformats.org/package/2006/metadata/core-properties"/>
    <ds:schemaRef ds:uri="d9837f2c-0831-4a23-8e3d-338c8fb70940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9360251B-F646-4F8D-ABCD-AE6CBFBAC0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875dd82-a7ab-4cd3-bf7a-6baf4630d5c9"/>
    <ds:schemaRef ds:uri="d9837f2c-0831-4a23-8e3d-338c8fb709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CA8CA79-1F52-41DE-BB9D-61B73598486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24</TotalTime>
  <Words>4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elali</dc:creator>
  <cp:lastModifiedBy>ahelali</cp:lastModifiedBy>
  <cp:revision>36</cp:revision>
  <dcterms:created xsi:type="dcterms:W3CDTF">2021-01-08T11:35:20Z</dcterms:created>
  <dcterms:modified xsi:type="dcterms:W3CDTF">2022-02-25T05:52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37BF873F645541AF4C0F4CF0373DF1</vt:lpwstr>
  </property>
</Properties>
</file>